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FE68D5-3B48-481E-9A9A-C244F38B6E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D76391-CF7E-40BD-A487-636C9B2FC2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2CA72-74DC-461F-B95C-D0EE7BD6C8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3C9D6-39BE-4CE0-838B-C1DAC8E8076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AE21F9-B174-4175-B1A5-2B2D522637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43B49-233D-4B97-BE5D-27A8A21708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CFD456-2165-4775-8E59-463AECEB46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F9CA5-9323-4235-9E6F-EA21526328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7646F7-0429-474E-8554-F1392C4BD0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96F94-BD7E-40D0-9758-A82B48E921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4BD72-8DAE-491B-92F3-BDDA2F91F3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3E063-6A67-4AA2-85C9-C83064E4AC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616513-514D-4703-8B9C-B13B5B1882B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68120" y="4140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89000" y="468360"/>
            <a:ext cx="6480000" cy="149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800" spc="-1" strike="noStrike">
                <a:solidFill>
                  <a:srgbClr val="000000"/>
                </a:solidFill>
                <a:latin typeface="Times New Roman"/>
              </a:rPr>
              <a:t>Data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Times New Roman"/>
              </a:rPr>
              <a:t>Raw data from MassArray analysis of CpG I.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Times New Roman"/>
              </a:rPr>
              <a:t>Methylation rate of each CpG units are shown as the mean value of triplicate independent analys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Times New Roman"/>
              </a:rPr>
              <a:t>C: healthy control, D: Patients with major depression, NA: not availabl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0" y="2411280"/>
          <a:ext cx="6858000" cy="61214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2411280"/>
                    <a:ext cx="6858000" cy="612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"/>
          <p:cNvSpPr/>
          <p:nvPr/>
        </p:nvSpPr>
        <p:spPr>
          <a:xfrm>
            <a:off x="241200" y="54468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6" name=""/>
          <p:cNvGraphicFramePr/>
          <p:nvPr/>
        </p:nvGraphicFramePr>
        <p:xfrm>
          <a:off x="0" y="1692360"/>
          <a:ext cx="6858000" cy="61214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7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1692360"/>
                    <a:ext cx="6858000" cy="612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960480" y="1265400"/>
            <a:ext cx="18396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0" y="1692360"/>
          <a:ext cx="6858000" cy="61214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0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1692360"/>
                    <a:ext cx="6858000" cy="612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"/>
          <p:cNvSpPr/>
          <p:nvPr/>
        </p:nvSpPr>
        <p:spPr>
          <a:xfrm>
            <a:off x="600120" y="2705040"/>
            <a:ext cx="18396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"/>
          <p:cNvGraphicFramePr/>
          <p:nvPr/>
        </p:nvGraphicFramePr>
        <p:xfrm>
          <a:off x="0" y="1692360"/>
          <a:ext cx="6858000" cy="61214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1692360"/>
                    <a:ext cx="6858000" cy="612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25T08:14:50Z</dcterms:created>
  <dc:creator>Owner</dc:creator>
  <dc:description/>
  <dc:language>en-US</dc:language>
  <cp:lastModifiedBy>Owner</cp:lastModifiedBy>
  <dcterms:modified xsi:type="dcterms:W3CDTF">2011-08-05T09:25:43Z</dcterms:modified>
  <cp:revision>11</cp:revision>
  <dc:subject/>
  <dc:title>スライド 1</dc:title>
</cp:coreProperties>
</file>